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17B65-F10E-44E9-A791-F05CC65853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D65251-9A86-435E-8A82-3860D91FFB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6D807-AEB5-4305-A1F5-63D1707A063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139B2-50EF-40D6-B43E-A245B511E1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928711-A043-4A75-8675-93D96E225D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4E4AA0-1A98-450B-83C5-59B8BC9179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95037-878C-4370-8356-925A8EA22F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F3328-C73A-4D81-8A4C-E0D3DC11F0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3897EB-7005-47CC-99A8-A47857F20D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3DA8A-501A-4477-98D7-D99250BBB9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203839-68C3-47B3-AD59-75A695B630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A9967C-9EF6-4BD5-AF8D-9A33F9F395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B875C3D-B9A3-4078-98FD-CB988135072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image" Target="../media/image1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6" descr=""/>
          <p:cNvPicPr/>
          <p:nvPr/>
        </p:nvPicPr>
        <p:blipFill>
          <a:blip r:embed="rId1"/>
          <a:srcRect l="0" t="10192" r="15211" b="0"/>
          <a:stretch/>
        </p:blipFill>
        <p:spPr>
          <a:xfrm>
            <a:off x="152280" y="482760"/>
            <a:ext cx="2786040" cy="24318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rcRect l="0" t="11144" r="14096" b="0"/>
          <a:stretch/>
        </p:blipFill>
        <p:spPr>
          <a:xfrm>
            <a:off x="152280" y="3505320"/>
            <a:ext cx="2827440" cy="2436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"/>
          <p:cNvPicPr/>
          <p:nvPr/>
        </p:nvPicPr>
        <p:blipFill>
          <a:blip r:embed="rId3"/>
          <a:srcRect l="0" t="11514" r="13855" b="0"/>
          <a:stretch/>
        </p:blipFill>
        <p:spPr>
          <a:xfrm>
            <a:off x="152280" y="6535800"/>
            <a:ext cx="2776680" cy="237312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462600" y="270000"/>
            <a:ext cx="199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ose-Effect Curve: MK1775 (WEE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2"/>
          <p:cNvSpPr/>
          <p:nvPr/>
        </p:nvSpPr>
        <p:spPr>
          <a:xfrm>
            <a:off x="96120" y="84240"/>
            <a:ext cx="26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 20"/>
          <p:cNvGrpSpPr/>
          <p:nvPr/>
        </p:nvGrpSpPr>
        <p:grpSpPr>
          <a:xfrm>
            <a:off x="2116080" y="1481040"/>
            <a:ext cx="682920" cy="957240"/>
            <a:chOff x="2116080" y="1481040"/>
            <a:chExt cx="682920" cy="957240"/>
          </a:xfrm>
        </p:grpSpPr>
        <p:sp>
          <p:nvSpPr>
            <p:cNvPr id="47" name="TextBox 13"/>
            <p:cNvSpPr/>
            <p:nvPr/>
          </p:nvSpPr>
          <p:spPr>
            <a:xfrm>
              <a:off x="2189520" y="148104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4"/>
            <p:cNvSpPr/>
            <p:nvPr/>
          </p:nvSpPr>
          <p:spPr>
            <a:xfrm>
              <a:off x="2188080" y="162324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HeyA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15"/>
            <p:cNvSpPr/>
            <p:nvPr/>
          </p:nvSpPr>
          <p:spPr>
            <a:xfrm>
              <a:off x="2189880" y="176544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2188800" y="190764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27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17"/>
            <p:cNvSpPr/>
            <p:nvPr/>
          </p:nvSpPr>
          <p:spPr>
            <a:xfrm>
              <a:off x="2189520" y="204984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8"/>
            <p:cNvSpPr/>
            <p:nvPr/>
          </p:nvSpPr>
          <p:spPr>
            <a:xfrm>
              <a:off x="2188800" y="219204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SKOV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3" name="Picture 6" descr=""/>
            <p:cNvPicPr/>
            <p:nvPr/>
          </p:nvPicPr>
          <p:blipFill>
            <a:blip r:embed="rId4"/>
            <a:srcRect l="88151" t="11762" r="7474" b="57301"/>
            <a:stretch/>
          </p:blipFill>
          <p:spPr>
            <a:xfrm>
              <a:off x="2116080" y="1531800"/>
              <a:ext cx="152640" cy="888840"/>
            </a:xfrm>
            <a:prstGeom prst="rect">
              <a:avLst/>
            </a:prstGeom>
            <a:ln w="0">
              <a:noFill/>
            </a:ln>
          </p:spPr>
        </p:pic>
      </p:grpSp>
      <p:graphicFrame>
        <p:nvGraphicFramePr>
          <p:cNvPr id="54" name=""/>
          <p:cNvGraphicFramePr/>
          <p:nvPr/>
        </p:nvGraphicFramePr>
        <p:xfrm>
          <a:off x="3382920" y="1063800"/>
          <a:ext cx="2362320" cy="1333440"/>
        </p:xfrm>
        <a:graphic>
          <a:graphicData uri="http://schemas.openxmlformats.org/drawingml/2006/table">
            <a:tbl>
              <a:tblPr/>
              <a:tblGrid>
                <a:gridCol w="533520"/>
                <a:gridCol w="584280"/>
                <a:gridCol w="622080"/>
                <a:gridCol w="622440"/>
              </a:tblGrid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49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47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ey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268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83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64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80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336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43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019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8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KOV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8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001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TextBox 7"/>
          <p:cNvSpPr/>
          <p:nvPr/>
        </p:nvSpPr>
        <p:spPr>
          <a:xfrm>
            <a:off x="462240" y="3257640"/>
            <a:ext cx="186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ose-Effect Curve: BI6727 (PLK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7"/>
          <p:cNvSpPr/>
          <p:nvPr/>
        </p:nvSpPr>
        <p:spPr>
          <a:xfrm>
            <a:off x="99360" y="3073320"/>
            <a:ext cx="26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8"/>
          <p:cNvSpPr/>
          <p:nvPr/>
        </p:nvSpPr>
        <p:spPr>
          <a:xfrm>
            <a:off x="2695680" y="2735280"/>
            <a:ext cx="3697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Arial Narrow"/>
              </a:rPr>
              <a:t>20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3382920" y="4068720"/>
          <a:ext cx="2362320" cy="1333440"/>
        </p:xfrm>
        <a:graphic>
          <a:graphicData uri="http://schemas.openxmlformats.org/drawingml/2006/table">
            <a:tbl>
              <a:tblPr/>
              <a:tblGrid>
                <a:gridCol w="533520"/>
                <a:gridCol w="584280"/>
                <a:gridCol w="622080"/>
                <a:gridCol w="622440"/>
              </a:tblGrid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433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02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ey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5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96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.9685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4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40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67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54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23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6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KOV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76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2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pSp>
        <p:nvGrpSpPr>
          <p:cNvPr id="59" name="Group 30"/>
          <p:cNvGrpSpPr/>
          <p:nvPr/>
        </p:nvGrpSpPr>
        <p:grpSpPr>
          <a:xfrm>
            <a:off x="2116080" y="4478400"/>
            <a:ext cx="682920" cy="957240"/>
            <a:chOff x="2116080" y="4478400"/>
            <a:chExt cx="682920" cy="957240"/>
          </a:xfrm>
        </p:grpSpPr>
        <p:sp>
          <p:nvSpPr>
            <p:cNvPr id="60" name="TextBox 31"/>
            <p:cNvSpPr/>
            <p:nvPr/>
          </p:nvSpPr>
          <p:spPr>
            <a:xfrm>
              <a:off x="2189520" y="447840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32"/>
            <p:cNvSpPr/>
            <p:nvPr/>
          </p:nvSpPr>
          <p:spPr>
            <a:xfrm>
              <a:off x="2188080" y="462060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HeyA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33"/>
            <p:cNvSpPr/>
            <p:nvPr/>
          </p:nvSpPr>
          <p:spPr>
            <a:xfrm>
              <a:off x="2189880" y="476280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34"/>
            <p:cNvSpPr/>
            <p:nvPr/>
          </p:nvSpPr>
          <p:spPr>
            <a:xfrm>
              <a:off x="2188800" y="490500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27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35"/>
            <p:cNvSpPr/>
            <p:nvPr/>
          </p:nvSpPr>
          <p:spPr>
            <a:xfrm>
              <a:off x="2189520" y="504720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36"/>
            <p:cNvSpPr/>
            <p:nvPr/>
          </p:nvSpPr>
          <p:spPr>
            <a:xfrm>
              <a:off x="2188800" y="518940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SKOV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Picture 6" descr=""/>
            <p:cNvPicPr/>
            <p:nvPr/>
          </p:nvPicPr>
          <p:blipFill>
            <a:blip r:embed="rId5"/>
            <a:srcRect l="88151" t="11762" r="7474" b="57301"/>
            <a:stretch/>
          </p:blipFill>
          <p:spPr>
            <a:xfrm>
              <a:off x="2116080" y="4529160"/>
              <a:ext cx="152640" cy="888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7" name="TextBox 7"/>
          <p:cNvSpPr/>
          <p:nvPr/>
        </p:nvSpPr>
        <p:spPr>
          <a:xfrm>
            <a:off x="465120" y="6272280"/>
            <a:ext cx="2308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Dose-Effect Curve: Oxozeaenol (MAP3K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9"/>
          <p:cNvSpPr/>
          <p:nvPr/>
        </p:nvSpPr>
        <p:spPr>
          <a:xfrm>
            <a:off x="100080" y="6087960"/>
            <a:ext cx="26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" name="Group 40"/>
          <p:cNvGrpSpPr/>
          <p:nvPr/>
        </p:nvGrpSpPr>
        <p:grpSpPr>
          <a:xfrm>
            <a:off x="2116080" y="7526160"/>
            <a:ext cx="682920" cy="957600"/>
            <a:chOff x="2116080" y="7526160"/>
            <a:chExt cx="682920" cy="957600"/>
          </a:xfrm>
        </p:grpSpPr>
        <p:sp>
          <p:nvSpPr>
            <p:cNvPr id="70" name="TextBox 41"/>
            <p:cNvSpPr/>
            <p:nvPr/>
          </p:nvSpPr>
          <p:spPr>
            <a:xfrm>
              <a:off x="2189520" y="752616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42"/>
            <p:cNvSpPr/>
            <p:nvPr/>
          </p:nvSpPr>
          <p:spPr>
            <a:xfrm>
              <a:off x="2188080" y="7668360"/>
              <a:ext cx="51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HeyA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43"/>
            <p:cNvSpPr/>
            <p:nvPr/>
          </p:nvSpPr>
          <p:spPr>
            <a:xfrm>
              <a:off x="2189880" y="781056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44"/>
            <p:cNvSpPr/>
            <p:nvPr/>
          </p:nvSpPr>
          <p:spPr>
            <a:xfrm>
              <a:off x="2188800" y="7952760"/>
              <a:ext cx="50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A278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45"/>
            <p:cNvSpPr/>
            <p:nvPr/>
          </p:nvSpPr>
          <p:spPr>
            <a:xfrm>
              <a:off x="2189520" y="8095320"/>
              <a:ext cx="609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OVCAR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46"/>
            <p:cNvSpPr/>
            <p:nvPr/>
          </p:nvSpPr>
          <p:spPr>
            <a:xfrm>
              <a:off x="2188800" y="82375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Calibri"/>
                </a:rPr>
                <a:t>SKOV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6" name="Picture 6" descr=""/>
            <p:cNvPicPr/>
            <p:nvPr/>
          </p:nvPicPr>
          <p:blipFill>
            <a:blip r:embed="rId6"/>
            <a:srcRect l="88151" t="11762" r="7474" b="57301"/>
            <a:stretch/>
          </p:blipFill>
          <p:spPr>
            <a:xfrm>
              <a:off x="2116080" y="7576920"/>
              <a:ext cx="152640" cy="889200"/>
            </a:xfrm>
            <a:prstGeom prst="rect">
              <a:avLst/>
            </a:prstGeom>
            <a:ln w="0">
              <a:noFill/>
            </a:ln>
          </p:spPr>
        </p:pic>
      </p:grpSp>
      <p:graphicFrame>
        <p:nvGraphicFramePr>
          <p:cNvPr id="77" name=""/>
          <p:cNvGraphicFramePr/>
          <p:nvPr/>
        </p:nvGraphicFramePr>
        <p:xfrm>
          <a:off x="3382920" y="7126200"/>
          <a:ext cx="2362320" cy="1333440"/>
        </p:xfrm>
        <a:graphic>
          <a:graphicData uri="http://schemas.openxmlformats.org/drawingml/2006/table">
            <a:tbl>
              <a:tblPr/>
              <a:tblGrid>
                <a:gridCol w="533520"/>
                <a:gridCol w="584280"/>
                <a:gridCol w="622080"/>
                <a:gridCol w="622440"/>
              </a:tblGrid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ell li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80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8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804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43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ey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25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49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59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62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27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44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9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OVCAR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.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27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73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0440">
                <a:tc>
                  <a:txBody>
                    <a:bodyPr lIns="12600" rIns="12600" tIns="12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KOV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77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96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28T17:37:29Z</dcterms:created>
  <dc:creator>kimmk2</dc:creator>
  <dc:description/>
  <dc:language>en-US</dc:language>
  <cp:lastModifiedBy>Christina Annunziata</cp:lastModifiedBy>
  <cp:lastPrinted>2013-06-28T19:11:52Z</cp:lastPrinted>
  <dcterms:modified xsi:type="dcterms:W3CDTF">2016-07-20T04:57:17Z</dcterms:modified>
  <cp:revision>22</cp:revision>
  <dc:subject/>
  <dc:title>PowerPoint Presentation</dc:title>
</cp:coreProperties>
</file>